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12"/>
  </p:notesMasterIdLst>
  <p:sldIdLst>
    <p:sldId id="292" r:id="rId3"/>
    <p:sldId id="293" r:id="rId4"/>
    <p:sldId id="294" r:id="rId5"/>
    <p:sldId id="296" r:id="rId6"/>
    <p:sldId id="297" r:id="rId7"/>
    <p:sldId id="298" r:id="rId8"/>
    <p:sldId id="302" r:id="rId9"/>
    <p:sldId id="303" r:id="rId10"/>
    <p:sldId id="304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B8B8B"/>
    <a:srgbClr val="3A3A3A"/>
    <a:srgbClr val="909090"/>
    <a:srgbClr val="767676"/>
    <a:srgbClr val="424242"/>
    <a:srgbClr val="1F1F1F"/>
    <a:srgbClr val="606060"/>
    <a:srgbClr val="040404"/>
    <a:srgbClr val="7F7F7F"/>
    <a:srgbClr val="15151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115" y="2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notesMaster" Target="notesMasters/notesMaster1.xml"/><Relationship Id="rId17" Type="http://schemas.microsoft.com/office/2016/11/relationships/changesInfo" Target="changesInfos/changesInfo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shed Sobhan (staff)" userId="43186704-b158-42cd-9519-a0381d720b3c" providerId="ADAL" clId="{D504DE4A-C210-45DE-BEF6-F57913B13DCC}"/>
    <pc:docChg chg="delSld">
      <pc:chgData name="Rashed Sobhan (staff)" userId="43186704-b158-42cd-9519-a0381d720b3c" providerId="ADAL" clId="{D504DE4A-C210-45DE-BEF6-F57913B13DCC}" dt="2025-08-15T10:13:46.057" v="2" actId="47"/>
      <pc:docMkLst>
        <pc:docMk/>
      </pc:docMkLst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3330451314" sldId="257"/>
        </pc:sldMkLst>
      </pc:sldChg>
      <pc:sldChg chg="del">
        <pc:chgData name="Rashed Sobhan (staff)" userId="43186704-b158-42cd-9519-a0381d720b3c" providerId="ADAL" clId="{D504DE4A-C210-45DE-BEF6-F57913B13DCC}" dt="2025-08-15T10:13:44.187" v="1" actId="47"/>
        <pc:sldMkLst>
          <pc:docMk/>
          <pc:sldMk cId="1831470527" sldId="305"/>
        </pc:sldMkLst>
      </pc:sldChg>
      <pc:sldChg chg="del">
        <pc:chgData name="Rashed Sobhan (staff)" userId="43186704-b158-42cd-9519-a0381d720b3c" providerId="ADAL" clId="{D504DE4A-C210-45DE-BEF6-F57913B13DCC}" dt="2025-08-15T10:13:46.057" v="2" actId="47"/>
        <pc:sldMkLst>
          <pc:docMk/>
          <pc:sldMk cId="260326784" sldId="306"/>
        </pc:sldMkLst>
      </pc:sldChg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2181702384" sldId="307"/>
        </pc:sldMkLst>
      </pc:sldChg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2795760577" sldId="308"/>
        </pc:sldMkLst>
      </pc:sldChg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2309453719" sldId="309"/>
        </pc:sldMkLst>
      </pc:sldChg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1039434837" sldId="310"/>
        </pc:sldMkLst>
      </pc:sldChg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731695129" sldId="311"/>
        </pc:sldMkLst>
      </pc:sldChg>
      <pc:sldChg chg="del">
        <pc:chgData name="Rashed Sobhan (staff)" userId="43186704-b158-42cd-9519-a0381d720b3c" providerId="ADAL" clId="{D504DE4A-C210-45DE-BEF6-F57913B13DCC}" dt="2025-08-15T10:13:40.872" v="0" actId="47"/>
        <pc:sldMkLst>
          <pc:docMk/>
          <pc:sldMk cId="2820838566" sldId="31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E9F11E-AA7E-48DB-9F5B-ABE467A82B7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86327D-72AB-45E3-9739-01399D9B2C9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17017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063A28-42DA-C0C3-0F8C-A8A8BC03E2C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A84A442-BE7D-61E9-B8A9-7CB56336EEB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A7E25A-8986-7DF8-1419-A802EC6180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5EFEBC-5C83-864E-853B-FF282A8106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81738B-2A56-0B57-BAAE-01A2642E6E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2889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1B863D-332A-8D45-99BD-4B877704BE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55DCC81-6328-9C70-B73A-9568F31A29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524515-046E-FDB8-EA08-05E37223A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59376-6909-2855-9A6D-5A3FC51CB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F44848-3B85-E286-F28A-7B4AD2CCAC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80278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BFE2748-C178-2933-37E3-1D55348671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8D0693-F938-5C44-2291-0459E13C40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6B6602-9FAA-4F64-14F5-411F6D2E0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BDEB54-A134-A74C-C5EA-5EF513721A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524488-5B5E-280A-344D-6506DE563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024516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50DE0-038D-6A25-5F2D-2B4A9A82FD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CCDF8D-FF30-63BF-D443-A88A9971787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1CFB7-E4CF-0CA7-46F1-58FB6AF35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1111A-3A3D-FDED-644B-5AAC103C7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3AE4BA-AE3E-3D05-2D21-FD5F4A42A3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123128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AC3A36-3591-45AA-9BFE-F4CF616B84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D63B80-CFBC-BFCC-98E7-14AA5AFF6C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161D1A-A0FA-D552-59F1-89BAA9D64C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980A5F-9A58-269A-E6AD-B4A372080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DFA0D2-B4FE-5805-8D36-DE6609103E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2962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AC7B7A-3A11-2AFA-9466-6D8EC077F6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FFA3C9-4318-EF64-4B24-56F3604FB6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EF9D5F-88FA-0E98-1995-CEDC048961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AD4B5D-1C92-9958-0E51-309756249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064C12-D6B3-FE5B-FA0E-5BD64000BB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391653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34A6C93-2E2F-AFCF-B9C1-DC87615011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119DA2-19F3-907A-B750-C67E934B73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A678892-6772-241B-AF6E-F96EA5BC71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3529E7-7CC0-646A-B9A7-576BC4902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F8AAE89-E97C-0E89-8C7F-1CE6E7FE3F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D495F7-E9E0-A59F-C6BD-A9B4F7872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17813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5BBF9E-06CF-6550-102B-7CEEB5BC9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0B4BF8-0A73-AE3E-15DC-0D60C5115F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50CCC0-4BE7-9BB4-4FCA-967778C2AB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AC57CB5-F62C-948F-2D4F-0D06019BE1D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B34330-AF74-9E43-91E7-9CC79EB5B9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5B9660-3433-B22D-2B72-ABE34C20B1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285D69A-0E2B-971F-EB52-1A5DAABCA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09E0B16-D36B-1BDC-D452-5824D9BD6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218184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2E5B5A-BF76-D6B0-6BE0-9FAD6211E9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173076-1027-D9C5-E7D5-934FB05908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833114-7D88-73E6-7BED-040079F859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6CBD1A-7B0F-5886-3451-90FE4F8812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8902211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17D5AF1-B814-ED15-FCFC-67B7A3B46D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F4E3534-FD5D-D379-6013-D0C0FE02A6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651DFF5-8C69-734B-E7A7-D73D8E892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954774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B266C3-64D2-F20F-CEA4-0345034B67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5FEF1C-78F3-AC27-C651-3E8E857F3F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4FE213-24EB-2AF8-28FA-3A8C78BC12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00D480-46D1-776A-74D7-070C8E71CC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92C886-0C4E-F3C0-2180-9142C38A0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260A14-3E46-CCDF-1218-A721F74C5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5793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0E03E4-B659-A957-FD81-D6394745E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895D18-6CB6-C3B5-6427-D457F08CFDC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08B42D-F3CA-7A4E-6083-15213E9F8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5D35B7-A2F3-121E-E2D7-61D845E0E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A929C0-3522-0CDF-4321-167ACBF17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404559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D5BB6C-FE01-D408-1E52-7002B99DB1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2621D8F-76DB-B438-EB12-25CE1C3898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49F1D7-B59D-7F3B-8C84-7070389678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F54B638-8460-C557-45A1-28826A9AE7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965F62-AA70-0504-7E87-07A7BB45CF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CCBCCF-EFE3-4393-FCAE-851769246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52465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EABFE9-E8C9-A50A-6489-2ED56223C4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D8FC7D-B187-F242-C7F1-81D5E9352C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7714EB-CAAD-520A-894A-15C0B127F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1AB28B-D4C7-65EB-FC90-64DEB2D535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687967-21EA-3DBA-C536-C2B6AB7584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355563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DDE6870-07FD-A8BA-886C-6DE71A6733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1179668-56FF-233A-68E3-A72A95BCA8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F46526-4798-C7F3-BA4C-67869FF83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BECC11-5B65-0DB8-A9D2-B12C75F4A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9DBF8F-4C09-40EE-A56C-4C82D834C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9684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10DACF-BFA7-BFAE-AD85-2EE69FD1D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8F1203-486C-F176-D13D-E68C47273E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D80B19-276D-E450-2ECD-585813AE97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406C22-66F7-D817-FF1B-07A9DAF73F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F76441-8FC3-E728-8D84-0C98349A5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2194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7E1480-C61C-56C3-DD0B-24D8387A5B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CAC214-1837-871C-3034-87D7ED2D6B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4C3F66-F647-F6BD-CBFD-6F0B4B4F9A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17107D-FF4F-2BC4-6C45-68D1865DA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065397-006F-C80B-1164-6B49AB5A5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E79041-42E2-FE61-82ED-E599A2ABC4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9016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E84AC9-902E-34E6-8CFC-E4387B5056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42165F-7E71-DFC1-DC28-6DBE63CE3A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F7802C-8B03-EC34-75DE-2B9E8C5DDD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206479D-673F-78F3-B5A7-A67246B4EB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DF9B81-24A6-9579-E9FB-C74C0AB56FC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040A8D6-AF41-A24B-D89A-23E342C67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A12008-26A0-0666-4E70-02D549A3DD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A72AFBC-85BC-0FB4-A987-4493B62BA3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17734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784491-CF89-1B5F-53A1-5C26F87E3C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1E720B-0916-9875-DC33-6229E2134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BDB6C5-1702-02B6-1AD5-49D8D8D9E0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F95C98-7743-4CF3-13E1-E52D58C15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481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A257E20-6AFE-6335-E2AD-4DEE9D29B1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8A9D7FC-FE6B-FA03-C6C0-01E1FEE5D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4610C32-2244-6FB8-F71E-C8E4B8DEE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3140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73B6D8-CA0F-94EF-E3DD-E720E492E0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409D60-55D1-8353-1A05-D44B9F5677D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F4FE37-8FDA-DBAB-2DF7-3542C81CD3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B8D7AC-9468-1E43-2430-5047D5EC55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0EBCB2-0FB5-6147-B21C-0FBAF376E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A0FB85-B7AA-04DD-D951-08B4D9AE7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4639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EBA2EE-EAF2-4E24-0187-4E163BAC58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E577086-9926-6310-4F7E-8A1FDCE1EAD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286CD6-6442-CCBF-5122-0E294EE379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1D40F8-34F0-BD42-8B0D-3ECC7A283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7A7B01-3316-6985-FF59-F203460AD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16CEA5-441C-5790-1F53-268F9D29C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8746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215E71-5939-948D-6910-184CF97610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4D2CD3-1697-FFC7-42E1-A8CAD25CD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BBDBBD-5E6A-F208-BA20-7ADDF7BB216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8AC453-76E2-4BEC-9062-B596C9F29E8F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45528E-81B5-A4B8-FD51-A51B7EBC87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7256B0-6C75-BD65-6C29-BE3EF53A48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64B806F-F647-4F6D-9DAB-F0C8C63ECB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8362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FF7066-0530-38C3-CE5C-4540FFAD19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E076907-C51F-1589-5B1E-8ADDC46EEB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3E50B9-C424-545C-FE79-7129547F0D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95D645-C037-4E2C-B91F-4435A539DF9C}" type="datetimeFigureOut">
              <a:rPr lang="en-GB" smtClean="0"/>
              <a:t>15/08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95DBE9-5EF8-35AA-2428-82F5C785DFB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DC56A9-0AFA-F118-B98D-ADE5639622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5B187D-A5DC-4594-9FDA-964840DE4D0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09120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3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FB24CFF-90BE-2302-8DFB-59FED45150F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96CDF54-85BE-6A7B-B5AC-CAECA19EA003}"/>
              </a:ext>
            </a:extLst>
          </p:cNvPr>
          <p:cNvSpPr txBox="1"/>
          <p:nvPr/>
        </p:nvSpPr>
        <p:spPr>
          <a:xfrm>
            <a:off x="1085850" y="228600"/>
            <a:ext cx="1696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2 – rest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0B8EF17-3F0E-3927-51D5-64D97BF74C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4343" y="802394"/>
            <a:ext cx="7772400" cy="511986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1434A562-7244-9E2B-695A-321355B6C6C5}"/>
              </a:ext>
            </a:extLst>
          </p:cNvPr>
          <p:cNvSpPr txBox="1"/>
          <p:nvPr/>
        </p:nvSpPr>
        <p:spPr>
          <a:xfrm>
            <a:off x="3671667" y="5922255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17.4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66.1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22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12.8</a:t>
            </a:r>
            <a:r>
              <a:rPr lang="en-GB" dirty="0"/>
              <a:t> ; </a:t>
            </a:r>
            <a:r>
              <a:rPr lang="en-GB" dirty="0">
                <a:solidFill>
                  <a:srgbClr val="FF00FF"/>
                </a:solidFill>
              </a:rPr>
              <a:t>PVF: 41.6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84.7 in mm</a:t>
            </a:r>
            <a:r>
              <a:rPr lang="en-GB" dirty="0"/>
              <a:t>; ARA: 110.5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06D49BB-38C9-8DCB-96FF-ECD0AA37567C}"/>
              </a:ext>
            </a:extLst>
          </p:cNvPr>
          <p:cNvSpPr/>
          <p:nvPr/>
        </p:nvSpPr>
        <p:spPr>
          <a:xfrm>
            <a:off x="2631889" y="1011677"/>
            <a:ext cx="1239719" cy="468815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2526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640CFB-EA0E-193B-30E1-CF2C1141846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0427768-581D-878D-8495-ACA410CAB89C}"/>
              </a:ext>
            </a:extLst>
          </p:cNvPr>
          <p:cNvSpPr txBox="1"/>
          <p:nvPr/>
        </p:nvSpPr>
        <p:spPr>
          <a:xfrm>
            <a:off x="1085850" y="228600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2 – clench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1015EE0-277A-B041-0942-4534DDC4D9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877754"/>
            <a:ext cx="7772400" cy="510249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C84D9FD-47E3-493B-047B-142BE92A2191}"/>
              </a:ext>
            </a:extLst>
          </p:cNvPr>
          <p:cNvSpPr txBox="1"/>
          <p:nvPr/>
        </p:nvSpPr>
        <p:spPr>
          <a:xfrm>
            <a:off x="3730033" y="5980245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3.7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42.6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6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23.2</a:t>
            </a:r>
            <a:r>
              <a:rPr lang="en-GB" dirty="0"/>
              <a:t> ; </a:t>
            </a:r>
            <a:r>
              <a:rPr lang="en-GB" dirty="0">
                <a:solidFill>
                  <a:srgbClr val="FF00FF"/>
                </a:solidFill>
              </a:rPr>
              <a:t>PVF: 41.8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112.8 in mm</a:t>
            </a:r>
            <a:r>
              <a:rPr lang="en-GB" dirty="0"/>
              <a:t>; ARA: 89.2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BDC7E4EF-8392-CCC3-95FD-3AF1CB2A9EE2}"/>
              </a:ext>
            </a:extLst>
          </p:cNvPr>
          <p:cNvSpPr/>
          <p:nvPr/>
        </p:nvSpPr>
        <p:spPr>
          <a:xfrm>
            <a:off x="2320605" y="1060315"/>
            <a:ext cx="1181353" cy="610006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5039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8F81EAD-BE30-0181-3CFC-1AFAD128DA5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01EFC6D-D47D-ECE1-0688-33607AFDE009}"/>
              </a:ext>
            </a:extLst>
          </p:cNvPr>
          <p:cNvSpPr txBox="1"/>
          <p:nvPr/>
        </p:nvSpPr>
        <p:spPr>
          <a:xfrm>
            <a:off x="1085850" y="228600"/>
            <a:ext cx="2192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2 – defecate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61945B2-E087-54D7-4B17-7CBF687D45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4550" y="870199"/>
            <a:ext cx="7772400" cy="5117602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6BB2CAA-F222-B45B-27EB-C6624FE0F996}"/>
              </a:ext>
            </a:extLst>
          </p:cNvPr>
          <p:cNvSpPr txBox="1"/>
          <p:nvPr/>
        </p:nvSpPr>
        <p:spPr>
          <a:xfrm>
            <a:off x="3574366" y="5987801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42.6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75.5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53.6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15.6</a:t>
            </a:r>
            <a:r>
              <a:rPr lang="en-GB" dirty="0"/>
              <a:t> ; </a:t>
            </a:r>
            <a:r>
              <a:rPr lang="en-GB" dirty="0">
                <a:solidFill>
                  <a:srgbClr val="FF00FF"/>
                </a:solidFill>
              </a:rPr>
              <a:t>PVF: 9.6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71 in mm</a:t>
            </a:r>
            <a:r>
              <a:rPr lang="en-GB" dirty="0"/>
              <a:t>; ARA: 141.4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A809BB8-261C-B969-790C-02D69A84533D}"/>
              </a:ext>
            </a:extLst>
          </p:cNvPr>
          <p:cNvSpPr/>
          <p:nvPr/>
        </p:nvSpPr>
        <p:spPr>
          <a:xfrm>
            <a:off x="2181919" y="1040860"/>
            <a:ext cx="1181353" cy="610005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5318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03028C-5A29-5427-565C-5F9B1CEFD11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E79F558-62EF-2977-8562-88FB96B609B9}"/>
              </a:ext>
            </a:extLst>
          </p:cNvPr>
          <p:cNvSpPr txBox="1"/>
          <p:nvPr/>
        </p:nvSpPr>
        <p:spPr>
          <a:xfrm>
            <a:off x="1085850" y="228600"/>
            <a:ext cx="1696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4 – res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2DEDAF4-5A10-9E49-EB1C-E33C0D61261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62065"/>
            <a:ext cx="7772400" cy="5119861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E1ABF86E-EE2E-99EA-D5DB-62098B12862E}"/>
              </a:ext>
            </a:extLst>
          </p:cNvPr>
          <p:cNvSpPr txBox="1"/>
          <p:nvPr/>
        </p:nvSpPr>
        <p:spPr>
          <a:xfrm>
            <a:off x="4031591" y="5881926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44.9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92.6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56.2</a:t>
            </a:r>
            <a:r>
              <a:rPr lang="en-GB" dirty="0"/>
              <a:t> 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4.8</a:t>
            </a:r>
            <a:r>
              <a:rPr lang="en-GB" dirty="0"/>
              <a:t> ; </a:t>
            </a:r>
            <a:r>
              <a:rPr lang="en-GB" dirty="0">
                <a:solidFill>
                  <a:srgbClr val="FF00FF"/>
                </a:solidFill>
              </a:rPr>
              <a:t>PVF: 18.5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76.7 in mm</a:t>
            </a:r>
            <a:r>
              <a:rPr lang="en-GB" dirty="0"/>
              <a:t>; ARA: 115.3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71CF8B3-E339-20DD-3C78-4255D99819FC}"/>
              </a:ext>
            </a:extLst>
          </p:cNvPr>
          <p:cNvSpPr/>
          <p:nvPr/>
        </p:nvSpPr>
        <p:spPr>
          <a:xfrm>
            <a:off x="2307077" y="976074"/>
            <a:ext cx="1181353" cy="619734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82332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C64C723-12D1-5F91-FB90-7418C5752FD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3B8B2E7-22EC-B94F-7418-0F2780C201FD}"/>
              </a:ext>
            </a:extLst>
          </p:cNvPr>
          <p:cNvSpPr txBox="1"/>
          <p:nvPr/>
        </p:nvSpPr>
        <p:spPr>
          <a:xfrm>
            <a:off x="1085850" y="228600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4 – clenc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3AB7CF2-A705-2431-2029-371837EEB3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784695"/>
            <a:ext cx="7772400" cy="5132967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C65FB3D-4E7D-04BF-5AAD-DDB4ADC55ADE}"/>
              </a:ext>
            </a:extLst>
          </p:cNvPr>
          <p:cNvSpPr txBox="1"/>
          <p:nvPr/>
        </p:nvSpPr>
        <p:spPr>
          <a:xfrm>
            <a:off x="4089957" y="5917662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5.7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59.7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23.3</a:t>
            </a:r>
            <a:r>
              <a:rPr lang="en-GB" dirty="0"/>
              <a:t> 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18.2</a:t>
            </a:r>
            <a:r>
              <a:rPr lang="en-GB" dirty="0"/>
              <a:t> ; </a:t>
            </a:r>
            <a:r>
              <a:rPr lang="en-GB" dirty="0">
                <a:solidFill>
                  <a:srgbClr val="FF00FF"/>
                </a:solidFill>
              </a:rPr>
              <a:t>PVF: 42.8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97.3 in mm</a:t>
            </a:r>
            <a:r>
              <a:rPr lang="en-GB" dirty="0"/>
              <a:t>; ARA: 72.9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95888E4-BCDD-647A-DD18-4E59E86B610B}"/>
              </a:ext>
            </a:extLst>
          </p:cNvPr>
          <p:cNvSpPr/>
          <p:nvPr/>
        </p:nvSpPr>
        <p:spPr>
          <a:xfrm>
            <a:off x="2297349" y="1011676"/>
            <a:ext cx="1181353" cy="532183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3C1BF18E-DCF5-2511-DCB6-03E32CF5F1E5}"/>
              </a:ext>
            </a:extLst>
          </p:cNvPr>
          <p:cNvSpPr/>
          <p:nvPr/>
        </p:nvSpPr>
        <p:spPr>
          <a:xfrm>
            <a:off x="2449749" y="1164076"/>
            <a:ext cx="1181353" cy="532183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98332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44C210-53AB-39B3-4B30-1036F435DD9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9D8E21F-CEE8-C363-D9D6-779C106839D5}"/>
              </a:ext>
            </a:extLst>
          </p:cNvPr>
          <p:cNvSpPr txBox="1"/>
          <p:nvPr/>
        </p:nvSpPr>
        <p:spPr>
          <a:xfrm>
            <a:off x="1085850" y="228600"/>
            <a:ext cx="2192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4 – defecat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A91DD59-DE07-A923-0CFD-70DE357076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877855"/>
            <a:ext cx="7772400" cy="510228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C25C530-3ED0-81E9-A9A6-9B7DCF8743C1}"/>
              </a:ext>
            </a:extLst>
          </p:cNvPr>
          <p:cNvSpPr txBox="1"/>
          <p:nvPr/>
        </p:nvSpPr>
        <p:spPr>
          <a:xfrm>
            <a:off x="3447931" y="5980144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38.1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92.2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71.4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33.7</a:t>
            </a:r>
            <a:r>
              <a:rPr lang="en-GB" dirty="0"/>
              <a:t> ; </a:t>
            </a:r>
            <a:r>
              <a:rPr lang="en-GB" dirty="0">
                <a:solidFill>
                  <a:srgbClr val="FF00FF"/>
                </a:solidFill>
              </a:rPr>
              <a:t>PVF: 3.9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49.9 in mm</a:t>
            </a:r>
            <a:r>
              <a:rPr lang="en-GB" dirty="0"/>
              <a:t>; ARA: 152.6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A12B8513-CEB9-9D28-CD03-68E543F08C8E}"/>
              </a:ext>
            </a:extLst>
          </p:cNvPr>
          <p:cNvSpPr/>
          <p:nvPr/>
        </p:nvSpPr>
        <p:spPr>
          <a:xfrm>
            <a:off x="2266578" y="1079770"/>
            <a:ext cx="1181353" cy="532183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74157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C473869-A7B7-8DC8-3667-F6259338FB4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25C09F8-C349-8665-CFE6-C43C79CA2E0E}"/>
              </a:ext>
            </a:extLst>
          </p:cNvPr>
          <p:cNvSpPr txBox="1"/>
          <p:nvPr/>
        </p:nvSpPr>
        <p:spPr>
          <a:xfrm>
            <a:off x="1085850" y="228600"/>
            <a:ext cx="1696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Subject 6 – rest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50A3228E-84DC-E0E4-2754-BC46A34DD6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76450" y="737148"/>
            <a:ext cx="7772400" cy="509795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6882B24-9D65-36A0-CA6C-E1CCEA907151}"/>
              </a:ext>
            </a:extLst>
          </p:cNvPr>
          <p:cNvSpPr txBox="1"/>
          <p:nvPr/>
        </p:nvSpPr>
        <p:spPr>
          <a:xfrm>
            <a:off x="3263832" y="5835102"/>
            <a:ext cx="539763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0FF00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M-line: 7.8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;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F9ED5">
                    <a:lumMod val="60000"/>
                    <a:lumOff val="4000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00099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H-line: 81.9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;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F9ED5">
                    <a:lumMod val="60000"/>
                    <a:lumOff val="4000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196B24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Rectum:35.3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;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F9ED5">
                    <a:lumMod val="60000"/>
                    <a:lumOff val="4000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FF3300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Bladder: 29.7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; 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A02B93">
                    <a:lumMod val="60000"/>
                    <a:lumOff val="4000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PVF: N/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;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srgbClr val="0F9ED5">
                    <a:lumMod val="60000"/>
                    <a:lumOff val="40000"/>
                  </a:srgbClr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 SI: 73.7 in mm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ptos" panose="02110004020202020204"/>
                <a:ea typeface="+mn-ea"/>
                <a:cs typeface="+mn-cs"/>
              </a:rPr>
              <a:t>; ARA: 86.7°. 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980AE97-B9F1-216F-CB07-4458CB260F9A}"/>
              </a:ext>
            </a:extLst>
          </p:cNvPr>
          <p:cNvSpPr/>
          <p:nvPr/>
        </p:nvSpPr>
        <p:spPr>
          <a:xfrm>
            <a:off x="2188723" y="933855"/>
            <a:ext cx="1184422" cy="561367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34562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963F11F-83C2-6792-BFD9-77F53A9FE81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119F502-584C-36EB-17C9-EAB17AA8B287}"/>
              </a:ext>
            </a:extLst>
          </p:cNvPr>
          <p:cNvSpPr txBox="1"/>
          <p:nvPr/>
        </p:nvSpPr>
        <p:spPr>
          <a:xfrm>
            <a:off x="1085850" y="228600"/>
            <a:ext cx="19928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6 – clench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C46DACC7-2E3F-5F1F-A9B0-7599E7A359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871162"/>
            <a:ext cx="7772400" cy="51156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C86CF1F-673B-2414-28B7-3CB32CCCB310}"/>
              </a:ext>
            </a:extLst>
          </p:cNvPr>
          <p:cNvSpPr txBox="1"/>
          <p:nvPr/>
        </p:nvSpPr>
        <p:spPr>
          <a:xfrm>
            <a:off x="3652212" y="5986838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10.1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66.3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12</a:t>
            </a:r>
            <a:r>
              <a:rPr lang="en-GB" dirty="0"/>
              <a:t> 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37.8</a:t>
            </a:r>
            <a:r>
              <a:rPr lang="en-GB" dirty="0"/>
              <a:t> ; </a:t>
            </a:r>
            <a:r>
              <a:rPr lang="en-GB" dirty="0">
                <a:solidFill>
                  <a:schemeClr val="accent5">
                    <a:lumMod val="60000"/>
                    <a:lumOff val="40000"/>
                  </a:schemeClr>
                </a:solidFill>
              </a:rPr>
              <a:t>PVF: N/A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92.6 in mm</a:t>
            </a:r>
            <a:r>
              <a:rPr lang="en-GB" dirty="0"/>
              <a:t>; ARA: 63.8°. 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D0679F39-7047-220D-3225-E1B8F6E54EDE}"/>
              </a:ext>
            </a:extLst>
          </p:cNvPr>
          <p:cNvSpPr/>
          <p:nvPr/>
        </p:nvSpPr>
        <p:spPr>
          <a:xfrm>
            <a:off x="2320605" y="1099226"/>
            <a:ext cx="1181353" cy="551639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4574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9E857AD-9792-FEFF-2AB5-1AF29B7882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2FEC5A5-A7AA-54FE-8871-BF90B077F899}"/>
              </a:ext>
            </a:extLst>
          </p:cNvPr>
          <p:cNvSpPr txBox="1"/>
          <p:nvPr/>
        </p:nvSpPr>
        <p:spPr>
          <a:xfrm>
            <a:off x="1085850" y="228600"/>
            <a:ext cx="21921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bject 6 – defecat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8FD942E-19A8-0BFB-E58A-357554694C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9800" y="875684"/>
            <a:ext cx="7772400" cy="510663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0F43206-613E-17F0-329F-1D21F2DF8469}"/>
              </a:ext>
            </a:extLst>
          </p:cNvPr>
          <p:cNvSpPr txBox="1"/>
          <p:nvPr/>
        </p:nvSpPr>
        <p:spPr>
          <a:xfrm>
            <a:off x="3652212" y="5982316"/>
            <a:ext cx="5043267" cy="65115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00FF00"/>
                </a:solidFill>
              </a:rPr>
              <a:t>M-line: 27.3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000099"/>
                </a:solidFill>
              </a:rPr>
              <a:t>H-line: 75.1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chemeClr val="accent3"/>
                </a:solidFill>
              </a:rPr>
              <a:t>Rectum: 36.7</a:t>
            </a:r>
            <a:r>
              <a:rPr lang="en-GB" dirty="0"/>
              <a:t> 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</a:t>
            </a:r>
            <a:r>
              <a:rPr lang="en-GB" dirty="0">
                <a:solidFill>
                  <a:srgbClr val="FF3300"/>
                </a:solidFill>
              </a:rPr>
              <a:t>Bladder: 3.9</a:t>
            </a:r>
            <a:r>
              <a:rPr lang="en-GB" dirty="0"/>
              <a:t> ; </a:t>
            </a:r>
            <a:r>
              <a:rPr lang="en-GB" dirty="0">
                <a:solidFill>
                  <a:schemeClr val="accent5">
                    <a:lumMod val="60000"/>
                    <a:lumOff val="40000"/>
                  </a:schemeClr>
                </a:solidFill>
              </a:rPr>
              <a:t>PVF: N/A </a:t>
            </a:r>
            <a:r>
              <a:rPr lang="en-GB" dirty="0"/>
              <a:t>;</a:t>
            </a:r>
            <a:r>
              <a:rPr lang="en-GB" dirty="0">
                <a:solidFill>
                  <a:schemeClr val="accent4">
                    <a:lumMod val="60000"/>
                    <a:lumOff val="40000"/>
                  </a:schemeClr>
                </a:solidFill>
              </a:rPr>
              <a:t> SI: 53.6 in mm</a:t>
            </a:r>
            <a:r>
              <a:rPr lang="en-GB" dirty="0"/>
              <a:t>; ARA: 90.8°.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D86E6D4C-8153-5AA2-1786-974DD45C0545}"/>
              </a:ext>
            </a:extLst>
          </p:cNvPr>
          <p:cNvSpPr/>
          <p:nvPr/>
        </p:nvSpPr>
        <p:spPr>
          <a:xfrm>
            <a:off x="2301149" y="1079770"/>
            <a:ext cx="1181353" cy="551640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899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24</TotalTime>
  <Words>312</Words>
  <Application>Microsoft Office PowerPoint</Application>
  <PresentationFormat>Widescreen</PresentationFormat>
  <Paragraphs>18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ptos</vt:lpstr>
      <vt:lpstr>Aptos Display</vt:lpstr>
      <vt:lpstr>Arial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ashed Sobhan (staff)</dc:creator>
  <cp:lastModifiedBy>Rashed Sobhan (staff)</cp:lastModifiedBy>
  <cp:revision>2</cp:revision>
  <dcterms:created xsi:type="dcterms:W3CDTF">2025-07-20T20:28:33Z</dcterms:created>
  <dcterms:modified xsi:type="dcterms:W3CDTF">2025-08-15T10:13:49Z</dcterms:modified>
</cp:coreProperties>
</file>